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5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1" autoAdjust="0"/>
    <p:restoredTop sz="91356"/>
  </p:normalViewPr>
  <p:slideViewPr>
    <p:cSldViewPr snapToGrid="0">
      <p:cViewPr varScale="1">
        <p:scale>
          <a:sx n="128" d="100"/>
          <a:sy n="128" d="100"/>
        </p:scale>
        <p:origin x="200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79D5F7-E523-4ABF-BCC2-5DE6C4348EC4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A557E-6B66-4C90-8D76-8BCDD15BE3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28756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79D5F7-E523-4ABF-BCC2-5DE6C4348EC4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A557E-6B66-4C90-8D76-8BCDD15BE3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01761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79D5F7-E523-4ABF-BCC2-5DE6C4348EC4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A557E-6B66-4C90-8D76-8BCDD15BE3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74427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79D5F7-E523-4ABF-BCC2-5DE6C4348EC4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A557E-6B66-4C90-8D76-8BCDD15BE3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14529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79D5F7-E523-4ABF-BCC2-5DE6C4348EC4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A557E-6B66-4C90-8D76-8BCDD15BE3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39072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79D5F7-E523-4ABF-BCC2-5DE6C4348EC4}" type="datetimeFigureOut">
              <a:rPr lang="en-US" smtClean="0"/>
              <a:t>6/2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A557E-6B66-4C90-8D76-8BCDD15BE3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89470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79D5F7-E523-4ABF-BCC2-5DE6C4348EC4}" type="datetimeFigureOut">
              <a:rPr lang="en-US" smtClean="0"/>
              <a:t>6/21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A557E-6B66-4C90-8D76-8BCDD15BE3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70013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79D5F7-E523-4ABF-BCC2-5DE6C4348EC4}" type="datetimeFigureOut">
              <a:rPr lang="en-US" smtClean="0"/>
              <a:t>6/21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A557E-6B66-4C90-8D76-8BCDD15BE3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91485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79D5F7-E523-4ABF-BCC2-5DE6C4348EC4}" type="datetimeFigureOut">
              <a:rPr lang="en-US" smtClean="0"/>
              <a:t>6/21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A557E-6B66-4C90-8D76-8BCDD15BE3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90484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79D5F7-E523-4ABF-BCC2-5DE6C4348EC4}" type="datetimeFigureOut">
              <a:rPr lang="en-US" smtClean="0"/>
              <a:t>6/2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A557E-6B66-4C90-8D76-8BCDD15BE3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63682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79D5F7-E523-4ABF-BCC2-5DE6C4348EC4}" type="datetimeFigureOut">
              <a:rPr lang="en-US" smtClean="0"/>
              <a:t>6/2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BA557E-6B66-4C90-8D76-8BCDD15BE3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3085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79D5F7-E523-4ABF-BCC2-5DE6C4348EC4}" type="datetimeFigureOut">
              <a:rPr lang="en-US" smtClean="0"/>
              <a:t>6/2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BA557E-6B66-4C90-8D76-8BCDD15BE3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89242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078B9494-70BD-4EEA-8377-8095E8ACB8D5}"/>
              </a:ext>
            </a:extLst>
          </p:cNvPr>
          <p:cNvGrpSpPr/>
          <p:nvPr/>
        </p:nvGrpSpPr>
        <p:grpSpPr>
          <a:xfrm>
            <a:off x="188843" y="438649"/>
            <a:ext cx="8607287" cy="4988115"/>
            <a:chOff x="1053505" y="1964423"/>
            <a:chExt cx="6719120" cy="3578124"/>
          </a:xfrm>
        </p:grpSpPr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1C9C55A2-059E-4158-BBA6-453DA608B535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053505" y="1976387"/>
              <a:ext cx="3441884" cy="3566160"/>
              <a:chOff x="2920407" y="196890"/>
              <a:chExt cx="3088872" cy="3200400"/>
            </a:xfrm>
          </p:grpSpPr>
          <p:grpSp>
            <p:nvGrpSpPr>
              <p:cNvPr id="20" name="Group 19">
                <a:extLst>
                  <a:ext uri="{FF2B5EF4-FFF2-40B4-BE49-F238E27FC236}">
                    <a16:creationId xmlns:a16="http://schemas.microsoft.com/office/drawing/2014/main" id="{8A40FC19-07A5-46E0-A2BE-B4273BB47044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3134720" y="196890"/>
                <a:ext cx="2874559" cy="3200400"/>
                <a:chOff x="1239600" y="971475"/>
                <a:chExt cx="2550000" cy="2839050"/>
              </a:xfrm>
            </p:grpSpPr>
            <p:pic>
              <p:nvPicPr>
                <p:cNvPr id="13" name="Picture 12">
                  <a:extLst>
                    <a:ext uri="{FF2B5EF4-FFF2-40B4-BE49-F238E27FC236}">
                      <a16:creationId xmlns:a16="http://schemas.microsoft.com/office/drawing/2014/main" id="{7F81A49A-0F90-4936-8D8C-4FC4E92B480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239600" y="971475"/>
                  <a:ext cx="2550000" cy="705000"/>
                </a:xfrm>
                <a:prstGeom prst="rect">
                  <a:avLst/>
                </a:prstGeom>
              </p:spPr>
            </p:pic>
            <p:pic>
              <p:nvPicPr>
                <p:cNvPr id="15" name="Picture 14">
                  <a:extLst>
                    <a:ext uri="{FF2B5EF4-FFF2-40B4-BE49-F238E27FC236}">
                      <a16:creationId xmlns:a16="http://schemas.microsoft.com/office/drawing/2014/main" id="{0FB2E022-7BDE-4ADA-8181-7C482E91C26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239600" y="1676475"/>
                  <a:ext cx="2550000" cy="705000"/>
                </a:xfrm>
                <a:prstGeom prst="rect">
                  <a:avLst/>
                </a:prstGeom>
              </p:spPr>
            </p:pic>
            <p:pic>
              <p:nvPicPr>
                <p:cNvPr id="17" name="Picture 16">
                  <a:extLst>
                    <a:ext uri="{FF2B5EF4-FFF2-40B4-BE49-F238E27FC236}">
                      <a16:creationId xmlns:a16="http://schemas.microsoft.com/office/drawing/2014/main" id="{AC577A21-E41C-4D90-8652-EA3C6134AD1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239600" y="2391000"/>
                  <a:ext cx="2550000" cy="705000"/>
                </a:xfrm>
                <a:prstGeom prst="rect">
                  <a:avLst/>
                </a:prstGeom>
              </p:spPr>
            </p:pic>
            <p:pic>
              <p:nvPicPr>
                <p:cNvPr id="19" name="Picture 18">
                  <a:extLst>
                    <a:ext uri="{FF2B5EF4-FFF2-40B4-BE49-F238E27FC236}">
                      <a16:creationId xmlns:a16="http://schemas.microsoft.com/office/drawing/2014/main" id="{28A48FD8-8351-4AD6-9E0D-DEAEA44A54B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239600" y="3105525"/>
                  <a:ext cx="2550000" cy="705000"/>
                </a:xfrm>
                <a:prstGeom prst="rect">
                  <a:avLst/>
                </a:prstGeom>
              </p:spPr>
            </p:pic>
          </p:grp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672E379F-A4D7-4929-8073-E8FEA78CE2E2}"/>
                  </a:ext>
                </a:extLst>
              </p:cNvPr>
              <p:cNvSpPr txBox="1"/>
              <p:nvPr/>
            </p:nvSpPr>
            <p:spPr>
              <a:xfrm>
                <a:off x="2920407" y="228600"/>
                <a:ext cx="42862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</p:grpSp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05D338A3-0D0F-4190-99E2-F8EE7488D523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4370157" y="1964423"/>
              <a:ext cx="3402468" cy="3566160"/>
              <a:chOff x="2920406" y="3391921"/>
              <a:chExt cx="3088873" cy="3237479"/>
            </a:xfrm>
          </p:grpSpPr>
          <p:grpSp>
            <p:nvGrpSpPr>
              <p:cNvPr id="22" name="Group 21">
                <a:extLst>
                  <a:ext uri="{FF2B5EF4-FFF2-40B4-BE49-F238E27FC236}">
                    <a16:creationId xmlns:a16="http://schemas.microsoft.com/office/drawing/2014/main" id="{6692CBA1-1140-40E1-BD66-BC7165A574EC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3115301" y="3429000"/>
                <a:ext cx="2893978" cy="3200400"/>
                <a:chOff x="5192475" y="981000"/>
                <a:chExt cx="2550000" cy="2820000"/>
              </a:xfrm>
            </p:grpSpPr>
            <p:pic>
              <p:nvPicPr>
                <p:cNvPr id="5" name="Picture 4">
                  <a:extLst>
                    <a:ext uri="{FF2B5EF4-FFF2-40B4-BE49-F238E27FC236}">
                      <a16:creationId xmlns:a16="http://schemas.microsoft.com/office/drawing/2014/main" id="{39881AEE-B898-4A04-8A18-9B9FA1EC3B8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192475" y="981000"/>
                  <a:ext cx="2550000" cy="705000"/>
                </a:xfrm>
                <a:prstGeom prst="rect">
                  <a:avLst/>
                </a:prstGeom>
              </p:spPr>
            </p:pic>
            <p:pic>
              <p:nvPicPr>
                <p:cNvPr id="7" name="Picture 6">
                  <a:extLst>
                    <a:ext uri="{FF2B5EF4-FFF2-40B4-BE49-F238E27FC236}">
                      <a16:creationId xmlns:a16="http://schemas.microsoft.com/office/drawing/2014/main" id="{E7736D88-AAD7-4C0D-8A64-E4FBE0C5E2D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192475" y="1686000"/>
                  <a:ext cx="2550000" cy="705000"/>
                </a:xfrm>
                <a:prstGeom prst="rect">
                  <a:avLst/>
                </a:prstGeom>
              </p:spPr>
            </p:pic>
            <p:pic>
              <p:nvPicPr>
                <p:cNvPr id="9" name="Picture 8">
                  <a:extLst>
                    <a:ext uri="{FF2B5EF4-FFF2-40B4-BE49-F238E27FC236}">
                      <a16:creationId xmlns:a16="http://schemas.microsoft.com/office/drawing/2014/main" id="{0C5C6882-75EA-44E8-BF4B-E36BB4B9221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192475" y="2391000"/>
                  <a:ext cx="2550000" cy="705000"/>
                </a:xfrm>
                <a:prstGeom prst="rect">
                  <a:avLst/>
                </a:prstGeom>
              </p:spPr>
            </p:pic>
            <p:pic>
              <p:nvPicPr>
                <p:cNvPr id="11" name="Picture 10">
                  <a:extLst>
                    <a:ext uri="{FF2B5EF4-FFF2-40B4-BE49-F238E27FC236}">
                      <a16:creationId xmlns:a16="http://schemas.microsoft.com/office/drawing/2014/main" id="{50CE646D-ADCB-46E5-B28B-D8AE35EDC3B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192475" y="3096000"/>
                  <a:ext cx="2550000" cy="705000"/>
                </a:xfrm>
                <a:prstGeom prst="rect">
                  <a:avLst/>
                </a:prstGeom>
              </p:spPr>
            </p:pic>
          </p:grp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2742B1F4-AD98-4449-B76A-DC3F4C3F2538}"/>
                  </a:ext>
                </a:extLst>
              </p:cNvPr>
              <p:cNvSpPr txBox="1"/>
              <p:nvPr/>
            </p:nvSpPr>
            <p:spPr>
              <a:xfrm>
                <a:off x="2920406" y="3391921"/>
                <a:ext cx="42862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</p:grpSp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3C0C9A0E-95A7-4AFB-9C9F-DE85AE21ADA0}"/>
              </a:ext>
            </a:extLst>
          </p:cNvPr>
          <p:cNvSpPr txBox="1"/>
          <p:nvPr/>
        </p:nvSpPr>
        <p:spPr>
          <a:xfrm>
            <a:off x="1042020" y="5660652"/>
            <a:ext cx="736712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3 Fig. PpSP42 nucleotide and amino acid variation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 algn="just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blogo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llustrating the relative frequencies of nucleotide polymorphisms in wild caught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. papatas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opulations from PPAW, PPJM, and PPJS. (B)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blogo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llustrating the relative frequencies of amino acid polymorphisms in wild caught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. papatas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opulations from PPAW, PPJM, and PPJS.</a:t>
            </a:r>
          </a:p>
        </p:txBody>
      </p:sp>
    </p:spTree>
    <p:extLst>
      <p:ext uri="{BB962C8B-B14F-4D97-AF65-F5344CB8AC3E}">
        <p14:creationId xmlns:p14="http://schemas.microsoft.com/office/powerpoint/2010/main" val="19878809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65</Words>
  <Application>Microsoft Macintosh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te Flanley</dc:creator>
  <cp:lastModifiedBy>Cate Flanley</cp:lastModifiedBy>
  <cp:revision>2</cp:revision>
  <dcterms:created xsi:type="dcterms:W3CDTF">2019-01-18T03:17:29Z</dcterms:created>
  <dcterms:modified xsi:type="dcterms:W3CDTF">2020-06-21T17:53:25Z</dcterms:modified>
</cp:coreProperties>
</file>